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4" r:id="rId2"/>
  </p:sldIdLst>
  <p:sldSz cx="12192000" cy="6858000"/>
  <p:notesSz cx="6858000" cy="9144000"/>
  <p:defaultTextStyle>
    <a:defPPr>
      <a:defRPr lang="en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93" autoAdjust="0"/>
    <p:restoredTop sz="94660"/>
  </p:normalViewPr>
  <p:slideViewPr>
    <p:cSldViewPr snapToGrid="0" showGuides="1">
      <p:cViewPr varScale="1">
        <p:scale>
          <a:sx n="103" d="100"/>
          <a:sy n="103" d="100"/>
        </p:scale>
        <p:origin x="798" y="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EBD3E1-6326-EAEA-AA4E-CB5664E9842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02D0526-7E61-4955-C031-9EA89C75622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DF2C1E-38EC-8B8A-A7BE-EC040CC8A6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AADFBC-C91F-5CBC-54B3-4C658984D5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52583A-2352-4C78-86BB-774E98FFE2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585378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EE30B9-C040-132F-A1C4-8172C28003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A03955B-6253-0D82-33E2-EDD1B7AB286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9A5B06-6F2A-5AE5-BE9C-DD07ECCCD6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FEE445-1621-FBC9-E792-43D7609863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2369B8-D6CE-27EA-7498-70B34AE5C0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816574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F880743-1CFB-AC71-338B-581B6772AD7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7010A6E-5332-4B08-0A1D-0DC9340D06D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1D51BD-84B4-7976-24EC-094010A8F0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331B07-82A2-E942-D06E-FFC5B0D4C3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AF6A76-8A1F-0688-EE6F-2078EAFE5A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5755514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F3E397-79D5-30F9-A8C0-F3B86E15F7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A9610C1-7A98-BF48-A2AF-683559E1A8C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00C6C2-AA6B-EB49-2583-64B6A950F8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EDCBB0F-A3C7-9429-880E-1FC64B1959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791E40-FF26-D932-0EF5-9DDB647766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2422116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73D8DF-71DA-8218-28D6-E7EC6AE785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61B982E-D9EE-5835-E4D2-350C5DAE5F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E7E71C-5258-791B-3B64-E2B907D766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4F21D1-DCBC-169D-670B-397A75146F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FD0D0E-E25F-538C-3CED-F7DB0DF359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7404806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D48F06-69FF-335F-695D-069C1F7E31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38A1050-E907-ECD8-155C-B94F5451174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03AD79C-6A2F-E8B2-F807-B0ADDE505BD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677B32F-B922-FC4C-493F-BEAC651157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69B2302-3A20-03B8-4459-5A6B28CCCE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4B91015-9DED-EFBE-5779-FCAC1CB788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6364862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3F1416-A4CA-1D91-A003-DD2AAF4356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C432463-0B34-A737-65BB-F6FCAC0A33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0113B73-E643-3092-50C9-836C9273E40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A147ECC-A451-466E-6ECB-1BE0B4500BD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7076EE5-C818-67D0-7AAB-5F69949C86C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D4E11F5-A3FB-42D9-A9D0-EFE9095218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70E7305-6858-DBEE-881F-76F2350B17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0975E74-89A1-F5D2-9C87-2D7AC19DD2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7213102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4F422E-8E1D-99B9-8B97-615EF683F8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240BCA1-6E04-5962-505B-0E17E5405D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616ACF3-E789-0CEA-3936-FD252725EC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7920E13-E437-C9B0-D852-7871D09420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5360957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A46A43E-DC2B-F021-58DF-61A3C4743A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57B6230-23B2-2C7D-EF85-43A070D264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B6D0EF5-46BD-D13C-40C4-DAFB822B68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4708934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CEBB53-9C26-4294-175C-1D460F48F7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903EC4A-5007-1117-DB6C-A6FDF0C1980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81B1829-202B-854C-33F2-199B1F88040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FCDE4F7-D23B-5599-8F0A-7F2F10EF1A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02A92CD-7C91-D174-09C5-DCC96EDDC5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0A75C27-6ECB-2D3D-5FF3-899FB7237C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1240718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8417BF-3F53-8031-0BAB-23C8DE041D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9C1DF2B-D017-650A-D31A-5C0EA899399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2728D31-D4E1-C75A-3FC7-5C3FD85F98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522918E-FA99-6637-6D5E-D507AFDC5B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8834CCB-EB1E-B7C4-EC23-60CCAECD90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CCC1839-D199-4C5B-37FF-3EA45899E8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2551123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A7C2DD5-AC70-7812-5B43-692C6DB307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2DDEA4D-A887-84F0-E009-C3EDB043B3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696AF1-DFBC-6713-64CB-66907C7F6DB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A10548-7A20-B0AA-D96C-22CF5C01CCC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8D20B0-C719-0828-4564-ACEF025D2EB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2285805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8C02F20D-8074-4AA9-8BB1-C941E9E03A1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-508" t="-13" r="44065" b="51070"/>
          <a:stretch/>
        </p:blipFill>
        <p:spPr bwMode="auto">
          <a:xfrm>
            <a:off x="3797116" y="2537424"/>
            <a:ext cx="4304487" cy="3054993"/>
          </a:xfrm>
          <a:prstGeom prst="rect">
            <a:avLst/>
          </a:prstGeom>
          <a:ln>
            <a:noFill/>
          </a:ln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C9F77EB4-424A-4241-B20F-E08F4E5769A5}"/>
              </a:ext>
            </a:extLst>
          </p:cNvPr>
          <p:cNvSpPr/>
          <p:nvPr/>
        </p:nvSpPr>
        <p:spPr>
          <a:xfrm>
            <a:off x="4703555" y="3514857"/>
            <a:ext cx="2820004" cy="691237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4A007E2-A59F-421D-A7B5-E0E67213913E}"/>
              </a:ext>
            </a:extLst>
          </p:cNvPr>
          <p:cNvSpPr txBox="1"/>
          <p:nvPr/>
        </p:nvSpPr>
        <p:spPr>
          <a:xfrm>
            <a:off x="7748061" y="3865630"/>
            <a:ext cx="10823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ZBP1-S-Sc</a:t>
            </a:r>
            <a:endParaRPr lang="en-DE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EAB4716-2823-4E95-A29A-12CFB425892A}"/>
              </a:ext>
            </a:extLst>
          </p:cNvPr>
          <p:cNvSpPr txBox="1"/>
          <p:nvPr/>
        </p:nvSpPr>
        <p:spPr>
          <a:xfrm>
            <a:off x="7728825" y="3530286"/>
            <a:ext cx="11208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ZBP1-L-NG</a:t>
            </a:r>
            <a:endParaRPr lang="en-DE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9E8552D-7E61-9EDF-D25E-0B6ADDF0C267}"/>
              </a:ext>
            </a:extLst>
          </p:cNvPr>
          <p:cNvSpPr txBox="1"/>
          <p:nvPr/>
        </p:nvSpPr>
        <p:spPr>
          <a:xfrm>
            <a:off x="998926" y="1031013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lot 2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46111C1-8C86-C539-49AC-17A5D5B1BCA5}"/>
              </a:ext>
            </a:extLst>
          </p:cNvPr>
          <p:cNvSpPr txBox="1"/>
          <p:nvPr/>
        </p:nvSpPr>
        <p:spPr>
          <a:xfrm rot="16200000">
            <a:off x="4747468" y="2552660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5FFFBF0-5B28-7528-016F-E21307BD99B1}"/>
              </a:ext>
            </a:extLst>
          </p:cNvPr>
          <p:cNvSpPr txBox="1"/>
          <p:nvPr/>
        </p:nvSpPr>
        <p:spPr>
          <a:xfrm rot="16200000">
            <a:off x="5385125" y="1342922"/>
            <a:ext cx="2809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 + ZBP1-S-Sc (moderate)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96F9DE5-705D-7E51-22FF-B454B15A272E}"/>
              </a:ext>
            </a:extLst>
          </p:cNvPr>
          <p:cNvSpPr txBox="1"/>
          <p:nvPr/>
        </p:nvSpPr>
        <p:spPr>
          <a:xfrm rot="16200000">
            <a:off x="4925585" y="2264039"/>
            <a:ext cx="9877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0EE1F1A-2118-EFC5-0886-56D2A4A89B34}"/>
              </a:ext>
            </a:extLst>
          </p:cNvPr>
          <p:cNvSpPr txBox="1"/>
          <p:nvPr/>
        </p:nvSpPr>
        <p:spPr>
          <a:xfrm rot="16200000">
            <a:off x="5684874" y="2143665"/>
            <a:ext cx="13003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mZ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L-NG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20A6DAE-8FA7-CAA1-3F37-19C607F32B6F}"/>
              </a:ext>
            </a:extLst>
          </p:cNvPr>
          <p:cNvSpPr txBox="1"/>
          <p:nvPr/>
        </p:nvSpPr>
        <p:spPr>
          <a:xfrm rot="16200000">
            <a:off x="5403263" y="2316789"/>
            <a:ext cx="9541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S-Sc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673A4A6-7CFF-F8FE-AC3A-1AABB05F7FA8}"/>
              </a:ext>
            </a:extLst>
          </p:cNvPr>
          <p:cNvSpPr txBox="1"/>
          <p:nvPr/>
        </p:nvSpPr>
        <p:spPr>
          <a:xfrm rot="16200000">
            <a:off x="5845971" y="1389179"/>
            <a:ext cx="2809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 + ZBP1-S-Sc (high)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C68CD63C-1147-2568-BEE5-702AA7652069}"/>
              </a:ext>
            </a:extLst>
          </p:cNvPr>
          <p:cNvCxnSpPr>
            <a:cxnSpLocks/>
          </p:cNvCxnSpPr>
          <p:nvPr/>
        </p:nvCxnSpPr>
        <p:spPr>
          <a:xfrm>
            <a:off x="4768161" y="2896673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95460D90-6B5F-97F6-4EAA-90B6F4647C33}"/>
              </a:ext>
            </a:extLst>
          </p:cNvPr>
          <p:cNvCxnSpPr>
            <a:cxnSpLocks/>
          </p:cNvCxnSpPr>
          <p:nvPr/>
        </p:nvCxnSpPr>
        <p:spPr>
          <a:xfrm>
            <a:off x="5231987" y="2896673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3CF91B3B-8B6E-692B-AB7A-808817987E20}"/>
              </a:ext>
            </a:extLst>
          </p:cNvPr>
          <p:cNvCxnSpPr>
            <a:cxnSpLocks/>
          </p:cNvCxnSpPr>
          <p:nvPr/>
        </p:nvCxnSpPr>
        <p:spPr>
          <a:xfrm>
            <a:off x="5692832" y="2896424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EAA803D8-70B5-A4B1-1058-6B1443859D96}"/>
              </a:ext>
            </a:extLst>
          </p:cNvPr>
          <p:cNvCxnSpPr>
            <a:cxnSpLocks/>
          </p:cNvCxnSpPr>
          <p:nvPr/>
        </p:nvCxnSpPr>
        <p:spPr>
          <a:xfrm>
            <a:off x="6147312" y="2896424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2E82652E-8A70-3B05-7E93-3F6224037373}"/>
              </a:ext>
            </a:extLst>
          </p:cNvPr>
          <p:cNvCxnSpPr>
            <a:cxnSpLocks/>
          </p:cNvCxnSpPr>
          <p:nvPr/>
        </p:nvCxnSpPr>
        <p:spPr>
          <a:xfrm>
            <a:off x="6596961" y="2898839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48B71E0A-0C99-63E0-CC98-36AF08D6841A}"/>
              </a:ext>
            </a:extLst>
          </p:cNvPr>
          <p:cNvCxnSpPr>
            <a:cxnSpLocks/>
          </p:cNvCxnSpPr>
          <p:nvPr/>
        </p:nvCxnSpPr>
        <p:spPr>
          <a:xfrm>
            <a:off x="7054161" y="2896424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E066623F-D712-4859-E156-405D7EE0D1BE}"/>
              </a:ext>
            </a:extLst>
          </p:cNvPr>
          <p:cNvSpPr txBox="1"/>
          <p:nvPr/>
        </p:nvSpPr>
        <p:spPr>
          <a:xfrm>
            <a:off x="4177921" y="2932342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3EA9705-B075-9153-A940-6CFC2CB5C0F2}"/>
              </a:ext>
            </a:extLst>
          </p:cNvPr>
          <p:cNvSpPr txBox="1"/>
          <p:nvPr/>
        </p:nvSpPr>
        <p:spPr>
          <a:xfrm>
            <a:off x="3797116" y="3211809"/>
            <a:ext cx="9092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mricasan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A2FEFD2-FD9B-827A-6705-9BF3AD1E38B9}"/>
              </a:ext>
            </a:extLst>
          </p:cNvPr>
          <p:cNvSpPr txBox="1"/>
          <p:nvPr/>
        </p:nvSpPr>
        <p:spPr>
          <a:xfrm>
            <a:off x="4703556" y="2915616"/>
            <a:ext cx="28200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Symbol" panose="05050102010706020507" pitchFamily="18" charset="2"/>
                <a:cs typeface="Arial" panose="020B0604020202020204" pitchFamily="34" charset="0"/>
              </a:rPr>
              <a:t>+    +    +    +    +    +    +   +    +   +    +    +</a:t>
            </a:r>
            <a:endParaRPr lang="en-DE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DA8C447-107E-9C59-DAA6-869A041F8C83}"/>
              </a:ext>
            </a:extLst>
          </p:cNvPr>
          <p:cNvSpPr txBox="1"/>
          <p:nvPr/>
        </p:nvSpPr>
        <p:spPr>
          <a:xfrm>
            <a:off x="4703556" y="3165002"/>
            <a:ext cx="28200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Symbol" panose="05050102010706020507" pitchFamily="18" charset="2"/>
                <a:cs typeface="Arial" panose="020B0604020202020204" pitchFamily="34" charset="0"/>
              </a:rPr>
              <a:t>-    +    -    +    -    +    -   +    -   +    -    +</a:t>
            </a:r>
            <a:endParaRPr lang="en-DE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E85F9455-B09B-4D5E-A069-5A734016AC3A}"/>
              </a:ext>
            </a:extLst>
          </p:cNvPr>
          <p:cNvCxnSpPr>
            <a:cxnSpLocks/>
          </p:cNvCxnSpPr>
          <p:nvPr/>
        </p:nvCxnSpPr>
        <p:spPr>
          <a:xfrm>
            <a:off x="4388286" y="4420216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4" name="TextBox 36">
            <a:extLst>
              <a:ext uri="{FF2B5EF4-FFF2-40B4-BE49-F238E27FC236}">
                <a16:creationId xmlns:a16="http://schemas.microsoft.com/office/drawing/2014/main" id="{3F86C13B-B7B4-4105-B254-5A8941429364}"/>
              </a:ext>
            </a:extLst>
          </p:cNvPr>
          <p:cNvSpPr txBox="1"/>
          <p:nvPr/>
        </p:nvSpPr>
        <p:spPr>
          <a:xfrm>
            <a:off x="4059900" y="427814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A41439F9-7FBF-46D3-9E23-92E2EE2BB39C}"/>
              </a:ext>
            </a:extLst>
          </p:cNvPr>
          <p:cNvCxnSpPr>
            <a:cxnSpLocks/>
          </p:cNvCxnSpPr>
          <p:nvPr/>
        </p:nvCxnSpPr>
        <p:spPr>
          <a:xfrm>
            <a:off x="4390100" y="4699020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6" name="TextBox 38">
            <a:extLst>
              <a:ext uri="{FF2B5EF4-FFF2-40B4-BE49-F238E27FC236}">
                <a16:creationId xmlns:a16="http://schemas.microsoft.com/office/drawing/2014/main" id="{5F9DBAB7-B10F-4E85-9F8D-A4A253DCBA15}"/>
              </a:ext>
            </a:extLst>
          </p:cNvPr>
          <p:cNvSpPr txBox="1"/>
          <p:nvPr/>
        </p:nvSpPr>
        <p:spPr>
          <a:xfrm>
            <a:off x="4061714" y="455695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2244E30D-272E-470E-8755-E1F133458B06}"/>
              </a:ext>
            </a:extLst>
          </p:cNvPr>
          <p:cNvCxnSpPr>
            <a:cxnSpLocks/>
          </p:cNvCxnSpPr>
          <p:nvPr/>
        </p:nvCxnSpPr>
        <p:spPr>
          <a:xfrm>
            <a:off x="4389569" y="4024160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8" name="TextBox 40">
            <a:extLst>
              <a:ext uri="{FF2B5EF4-FFF2-40B4-BE49-F238E27FC236}">
                <a16:creationId xmlns:a16="http://schemas.microsoft.com/office/drawing/2014/main" id="{C0585689-D2A5-43D3-AF92-EFE8D1BF6387}"/>
              </a:ext>
            </a:extLst>
          </p:cNvPr>
          <p:cNvSpPr txBox="1"/>
          <p:nvPr/>
        </p:nvSpPr>
        <p:spPr>
          <a:xfrm>
            <a:off x="4061183" y="388209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D894D6D3-CEB1-45CE-B58F-4ACA1577A0DB}"/>
              </a:ext>
            </a:extLst>
          </p:cNvPr>
          <p:cNvCxnSpPr>
            <a:cxnSpLocks/>
          </p:cNvCxnSpPr>
          <p:nvPr/>
        </p:nvCxnSpPr>
        <p:spPr>
          <a:xfrm>
            <a:off x="4388095" y="3797685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0" name="TextBox 42">
            <a:extLst>
              <a:ext uri="{FF2B5EF4-FFF2-40B4-BE49-F238E27FC236}">
                <a16:creationId xmlns:a16="http://schemas.microsoft.com/office/drawing/2014/main" id="{4A6AAF46-1BD9-4D5D-9E4A-12443A48C9CB}"/>
              </a:ext>
            </a:extLst>
          </p:cNvPr>
          <p:cNvSpPr txBox="1"/>
          <p:nvPr/>
        </p:nvSpPr>
        <p:spPr>
          <a:xfrm>
            <a:off x="4059709" y="364884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20C1A71E-8798-487A-AB51-71A59DD3462A}"/>
              </a:ext>
            </a:extLst>
          </p:cNvPr>
          <p:cNvCxnSpPr>
            <a:cxnSpLocks/>
          </p:cNvCxnSpPr>
          <p:nvPr/>
        </p:nvCxnSpPr>
        <p:spPr>
          <a:xfrm>
            <a:off x="4388286" y="5310656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2" name="TextBox 38">
            <a:extLst>
              <a:ext uri="{FF2B5EF4-FFF2-40B4-BE49-F238E27FC236}">
                <a16:creationId xmlns:a16="http://schemas.microsoft.com/office/drawing/2014/main" id="{370D5884-8419-4DB3-8550-A120C6121DA3}"/>
              </a:ext>
            </a:extLst>
          </p:cNvPr>
          <p:cNvSpPr txBox="1"/>
          <p:nvPr/>
        </p:nvSpPr>
        <p:spPr>
          <a:xfrm>
            <a:off x="4059900" y="516858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18B17FD7-94CE-4185-AAF4-784073D51BAA}"/>
              </a:ext>
            </a:extLst>
          </p:cNvPr>
          <p:cNvCxnSpPr>
            <a:cxnSpLocks/>
          </p:cNvCxnSpPr>
          <p:nvPr/>
        </p:nvCxnSpPr>
        <p:spPr>
          <a:xfrm>
            <a:off x="4388095" y="3667301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4" name="TextBox 42">
            <a:extLst>
              <a:ext uri="{FF2B5EF4-FFF2-40B4-BE49-F238E27FC236}">
                <a16:creationId xmlns:a16="http://schemas.microsoft.com/office/drawing/2014/main" id="{640FEF22-010C-4949-88AC-620B6E3F48FE}"/>
              </a:ext>
            </a:extLst>
          </p:cNvPr>
          <p:cNvSpPr txBox="1"/>
          <p:nvPr/>
        </p:nvSpPr>
        <p:spPr>
          <a:xfrm>
            <a:off x="3974749" y="3498139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684591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4</Words>
  <Application>Microsoft Office PowerPoint</Application>
  <PresentationFormat>Widescreen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smin Carvalho Schäfer</dc:creator>
  <cp:lastModifiedBy>mnagata</cp:lastModifiedBy>
  <cp:revision>7</cp:revision>
  <dcterms:created xsi:type="dcterms:W3CDTF">2024-08-13T14:46:47Z</dcterms:created>
  <dcterms:modified xsi:type="dcterms:W3CDTF">2024-08-14T22:24:04Z</dcterms:modified>
</cp:coreProperties>
</file>